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77" r:id="rId3"/>
    <p:sldId id="27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93E4C-6FA3-4C33-A7B9-3DB6FFEF76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2E9259B-E75C-4905-A7C2-5D5B65D368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F1128-FDF8-4C79-BA0C-791C0173D3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05773-E151-4ACD-A241-0966207674B0}" type="datetimeFigureOut">
              <a:rPr lang="en-US" smtClean="0"/>
              <a:t>1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792AB2-242C-4739-9010-A73D9C8BB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7A23F2-A950-4BAC-B4A0-4C61C736FD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C5C6C-AEA3-4C90-8900-C80AAB367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181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DDE00-BB5E-4DC4-9A6A-D37E426643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5106670-C13A-4B5C-B541-5A70456076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3371B7-2623-44DA-AEF8-64315E8D71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05773-E151-4ACD-A241-0966207674B0}" type="datetimeFigureOut">
              <a:rPr lang="en-US" smtClean="0"/>
              <a:t>1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AA7A64-7300-4CED-8260-3838B02536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3F4604-6230-4F00-82F5-192D71079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C5C6C-AEA3-4C90-8900-C80AAB367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962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AF9C62-ABB9-497E-8643-841684F323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0C852D-B621-47EA-B3A0-971EB58679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3D0FEB-7AB2-4C8E-988C-990CB4041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05773-E151-4ACD-A241-0966207674B0}" type="datetimeFigureOut">
              <a:rPr lang="en-US" smtClean="0"/>
              <a:t>1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AAEFBA-33A8-49CC-976A-EE3D17DBB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90E6C7-0FAF-4D4C-A013-542FDAB556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C5C6C-AEA3-4C90-8900-C80AAB367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311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4B79BF-F713-47CC-9BC0-38F458BDA2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E656A2-978E-4709-9ED3-C7DD438847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B58DC3-1C10-4FCC-9AB1-CA617CA11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05773-E151-4ACD-A241-0966207674B0}" type="datetimeFigureOut">
              <a:rPr lang="en-US" smtClean="0"/>
              <a:t>1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F707AB-71E2-48A6-81C2-B4E1BD2B8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D86FF1-64D5-4DD7-B210-057614103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C5C6C-AEA3-4C90-8900-C80AAB367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113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A331BE-2E7E-4759-9290-D3B02ED3BC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315DFB-86D2-43F3-B272-FA040534EA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B08A80-94A4-44DA-9B90-B13E58C2D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05773-E151-4ACD-A241-0966207674B0}" type="datetimeFigureOut">
              <a:rPr lang="en-US" smtClean="0"/>
              <a:t>1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1985DC-7ADF-4DDB-B4AC-9784A85530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E188C7-5400-4211-9478-FA8C1CF16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C5C6C-AEA3-4C90-8900-C80AAB367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283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CDBFA0-2664-4EE5-871B-E5D80D478E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6AEDD4-953E-4355-BB17-0CA8902527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D1B842-A2DB-4239-A791-024FE4C42E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E447BF-D663-4B0A-9F62-D073F0FF21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05773-E151-4ACD-A241-0966207674B0}" type="datetimeFigureOut">
              <a:rPr lang="en-US" smtClean="0"/>
              <a:t>1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049EE6-451B-48D4-9FB4-E6C2B2F33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4C2FF7-8195-4059-A949-1193A9DD89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C5C6C-AEA3-4C90-8900-C80AAB367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815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44F35F-573D-46A0-8823-6EB8460DCF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8B47F9-39D5-46C4-9627-15262C86DA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CE111B-4DE8-40C7-8152-56292A85D1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2A75A4-7EF3-488F-B1AF-2E919805D6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0A02BF-AD4E-4CE7-AB9A-7A8CAE0036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B5C47ED-C126-4156-94B0-8DA4E4581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05773-E151-4ACD-A241-0966207674B0}" type="datetimeFigureOut">
              <a:rPr lang="en-US" smtClean="0"/>
              <a:t>1/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E0B865C-EA74-49B8-AFFB-CF229A474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6C84DE-7630-4684-B5F8-063B8D7F4B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C5C6C-AEA3-4C90-8900-C80AAB367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486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7699D7-DA27-4EAD-87B7-D2CAFEA469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92BF19-1B00-4392-B95D-46FA59A6C7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05773-E151-4ACD-A241-0966207674B0}" type="datetimeFigureOut">
              <a:rPr lang="en-US" smtClean="0"/>
              <a:t>1/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DEBA23-5AE4-40E2-B900-7ABF1B083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42821E-2455-43ED-B44D-825BA1CCE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C5C6C-AEA3-4C90-8900-C80AAB367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925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497325-9C76-419B-ABA4-52FD1F37D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05773-E151-4ACD-A241-0966207674B0}" type="datetimeFigureOut">
              <a:rPr lang="en-US" smtClean="0"/>
              <a:t>1/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7BB680-5F1E-48EB-84B7-35F442D50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936630C-B739-49C6-ACAD-8C091DB04D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C5C6C-AEA3-4C90-8900-C80AAB367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094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0EABCA-1315-4D3D-807B-9A6DA61ED5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D30A35-D41A-4FB2-AD9F-37550E56E5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E5B7BD-DC80-4902-863D-F1A43038B3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10CD60-C210-4BFC-A87C-8E8D70476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05773-E151-4ACD-A241-0966207674B0}" type="datetimeFigureOut">
              <a:rPr lang="en-US" smtClean="0"/>
              <a:t>1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1F3A68-8133-4AE5-8F80-4B7F13F6B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E43A6E-DB6F-4147-AFBC-6A31B5000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C5C6C-AEA3-4C90-8900-C80AAB367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583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F71F9B-8502-49C5-A4EE-A8C30D2B8B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B10196E-FBCA-4676-91FF-B01E6D756E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E8570D-4892-465F-8DA0-A2639CD6AD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3A2B27-A61D-4E95-A521-8DF4F1FF4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05773-E151-4ACD-A241-0966207674B0}" type="datetimeFigureOut">
              <a:rPr lang="en-US" smtClean="0"/>
              <a:t>1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E31956-1496-47E4-9276-D941B2119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F6E65C-4E20-4C99-8781-BA4D64C01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C5C6C-AEA3-4C90-8900-C80AAB367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866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6370AE7-FB65-439F-A3C6-3863F1AE90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4046A0-4462-4EA4-BED6-311F3CB3F7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53BC4B-EFAF-4195-8DD9-5600816A51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205773-E151-4ACD-A241-0966207674B0}" type="datetimeFigureOut">
              <a:rPr lang="en-US" smtClean="0"/>
              <a:t>1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783D67-514E-4347-BCB5-4CF97019CE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A78821-EDE3-4D5B-9F9C-B3744D24C8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DC5C6C-AEA3-4C90-8900-C80AAB367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340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977E52C-5156-42E7-8C8B-4CD10722A9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259658" y="224935"/>
            <a:ext cx="7672684" cy="412632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9D5A6E3-5EBD-4B72-9A6A-58E1CEE6DD40}"/>
              </a:ext>
            </a:extLst>
          </p:cNvPr>
          <p:cNvSpPr txBox="1"/>
          <p:nvPr/>
        </p:nvSpPr>
        <p:spPr>
          <a:xfrm>
            <a:off x="2701255" y="4622334"/>
            <a:ext cx="671958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1. A</a:t>
            </a:r>
            <a:r>
              <a:rPr lang="en-US" dirty="0"/>
              <a:t>) The deletion scheme for hfb9a. The hfb9a gene was replaced with the gene for hygromycin resistance by homologous recombination. </a:t>
            </a:r>
            <a:r>
              <a:rPr lang="en-US" b="1" dirty="0"/>
              <a:t>B</a:t>
            </a:r>
            <a:r>
              <a:rPr lang="en-US" dirty="0"/>
              <a:t>) Confirmation of gene deletion by PCR. </a:t>
            </a:r>
          </a:p>
        </p:txBody>
      </p:sp>
    </p:spTree>
    <p:extLst>
      <p:ext uri="{BB962C8B-B14F-4D97-AF65-F5344CB8AC3E}">
        <p14:creationId xmlns:p14="http://schemas.microsoft.com/office/powerpoint/2010/main" val="16126078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80A64B9-9784-4BBC-8BF7-56F0DF37BA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47644" y="96801"/>
            <a:ext cx="6906497" cy="517987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36430D6-F91A-4614-9FC5-9762AE9C341D}"/>
              </a:ext>
            </a:extLst>
          </p:cNvPr>
          <p:cNvSpPr txBox="1"/>
          <p:nvPr/>
        </p:nvSpPr>
        <p:spPr>
          <a:xfrm>
            <a:off x="2701255" y="5461233"/>
            <a:ext cx="67195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2. </a:t>
            </a:r>
            <a:r>
              <a:rPr lang="en-US" dirty="0"/>
              <a:t>Radial growth rate comparison between the wild-type strain (WT) and the mutant strains.</a:t>
            </a:r>
          </a:p>
        </p:txBody>
      </p:sp>
    </p:spTree>
    <p:extLst>
      <p:ext uri="{BB962C8B-B14F-4D97-AF65-F5344CB8AC3E}">
        <p14:creationId xmlns:p14="http://schemas.microsoft.com/office/powerpoint/2010/main" val="42692584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14C2D48B-F8B1-46CA-8F35-29117ACB50AC}"/>
              </a:ext>
            </a:extLst>
          </p:cNvPr>
          <p:cNvGrpSpPr/>
          <p:nvPr/>
        </p:nvGrpSpPr>
        <p:grpSpPr>
          <a:xfrm>
            <a:off x="471961" y="142306"/>
            <a:ext cx="11717720" cy="4593586"/>
            <a:chOff x="471961" y="1132207"/>
            <a:chExt cx="11717720" cy="459358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5DA9390-21FC-492A-85C4-5273A8EF734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71961" y="1132207"/>
              <a:ext cx="6124781" cy="4593586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AB1C5AD-A6D5-478D-BB21-7FB7B384402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096000" y="1143869"/>
              <a:ext cx="6093681" cy="4570261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7DDAD8E-B26B-4D4C-AE5C-08BF55EFD233}"/>
                </a:ext>
              </a:extLst>
            </p:cNvPr>
            <p:cNvSpPr txBox="1"/>
            <p:nvPr/>
          </p:nvSpPr>
          <p:spPr>
            <a:xfrm>
              <a:off x="626075" y="1359243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Charter" panose="02000503060000020004" pitchFamily="50" charset="0"/>
                </a:rPr>
                <a:t>A.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758B9DA-18C2-4B8B-9808-607ADFD2F956}"/>
                </a:ext>
              </a:extLst>
            </p:cNvPr>
            <p:cNvSpPr txBox="1"/>
            <p:nvPr/>
          </p:nvSpPr>
          <p:spPr>
            <a:xfrm>
              <a:off x="6354595" y="1359243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Charter" panose="02000503060000020004" pitchFamily="50" charset="0"/>
                </a:rPr>
                <a:t>B.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41847831-6B4C-494F-AF37-2693DCFCBD3D}"/>
              </a:ext>
            </a:extLst>
          </p:cNvPr>
          <p:cNvSpPr txBox="1"/>
          <p:nvPr/>
        </p:nvSpPr>
        <p:spPr>
          <a:xfrm>
            <a:off x="2701255" y="5461233"/>
            <a:ext cx="671958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3. A</a:t>
            </a:r>
            <a:r>
              <a:rPr lang="en-US" dirty="0"/>
              <a:t>) Biocontrol activity of the wild-type and mutant strains against </a:t>
            </a:r>
            <a:r>
              <a:rPr lang="en-US" i="1" dirty="0"/>
              <a:t>Pythium </a:t>
            </a:r>
            <a:r>
              <a:rPr lang="en-US" i="1" dirty="0" err="1"/>
              <a:t>ultimum</a:t>
            </a:r>
            <a:r>
              <a:rPr lang="en-US" dirty="0"/>
              <a:t>. </a:t>
            </a:r>
            <a:r>
              <a:rPr lang="en-US" b="1" dirty="0"/>
              <a:t>B</a:t>
            </a:r>
            <a:r>
              <a:rPr lang="en-US" dirty="0"/>
              <a:t>) Growth of the wild-type and mutant strains in confrontation with </a:t>
            </a:r>
            <a:r>
              <a:rPr lang="en-US" i="1" dirty="0"/>
              <a:t>Rhizoctonia </a:t>
            </a:r>
            <a:r>
              <a:rPr lang="en-US" i="1" dirty="0" err="1"/>
              <a:t>solani</a:t>
            </a:r>
            <a:r>
              <a:rPr lang="en-US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4488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93</Words>
  <Application>Microsoft Office PowerPoint</Application>
  <PresentationFormat>Widescreen</PresentationFormat>
  <Paragraphs>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Charter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 Taylor</dc:creator>
  <cp:lastModifiedBy>Jim Taylor</cp:lastModifiedBy>
  <cp:revision>3</cp:revision>
  <dcterms:created xsi:type="dcterms:W3CDTF">2021-01-07T16:05:05Z</dcterms:created>
  <dcterms:modified xsi:type="dcterms:W3CDTF">2021-01-07T16:30:25Z</dcterms:modified>
</cp:coreProperties>
</file>